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2" autoAdjust="0"/>
    <p:restoredTop sz="94660"/>
  </p:normalViewPr>
  <p:slideViewPr>
    <p:cSldViewPr snapToGrid="0" showGuides="1">
      <p:cViewPr varScale="1">
        <p:scale>
          <a:sx n="97" d="100"/>
          <a:sy n="97" d="100"/>
        </p:scale>
        <p:origin x="78" y="25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cat>
            <c:strRef>
              <c:f>(graph!$C$7,graph!$C$8)</c:f>
              <c:strCache>
                <c:ptCount val="2"/>
                <c:pt idx="0">
                  <c:v>RplB 1-121</c:v>
                </c:pt>
                <c:pt idx="1">
                  <c:v>RplB 122-273</c:v>
                </c:pt>
              </c:strCache>
            </c:strRef>
          </c:cat>
          <c:val>
            <c:numRef>
              <c:f>(graph!$F$7,graph!$F$8)</c:f>
              <c:numCache>
                <c:formatCode>General</c:formatCode>
                <c:ptCount val="2"/>
                <c:pt idx="0">
                  <c:v>5028.58</c:v>
                </c:pt>
                <c:pt idx="1">
                  <c:v>5676.60550458715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F01-4E75-A5CB-007DBCD60E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33241664"/>
        <c:axId val="1833242912"/>
      </c:barChart>
      <c:catAx>
        <c:axId val="183324166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833242912"/>
        <c:crosses val="autoZero"/>
        <c:auto val="1"/>
        <c:lblAlgn val="ctr"/>
        <c:lblOffset val="0"/>
        <c:noMultiLvlLbl val="0"/>
      </c:catAx>
      <c:valAx>
        <c:axId val="1833242912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8332416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C3054-F838-4E6C-A918-8EF68719D4D9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19EED-20FB-43EA-93C5-3D37481503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6538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C3054-F838-4E6C-A918-8EF68719D4D9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19EED-20FB-43EA-93C5-3D37481503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2080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C3054-F838-4E6C-A918-8EF68719D4D9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19EED-20FB-43EA-93C5-3D37481503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38282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C3054-F838-4E6C-A918-8EF68719D4D9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19EED-20FB-43EA-93C5-3D37481503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15985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C3054-F838-4E6C-A918-8EF68719D4D9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19EED-20FB-43EA-93C5-3D37481503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1733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C3054-F838-4E6C-A918-8EF68719D4D9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19EED-20FB-43EA-93C5-3D37481503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57829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C3054-F838-4E6C-A918-8EF68719D4D9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19EED-20FB-43EA-93C5-3D37481503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11514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C3054-F838-4E6C-A918-8EF68719D4D9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19EED-20FB-43EA-93C5-3D37481503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692861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C3054-F838-4E6C-A918-8EF68719D4D9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19EED-20FB-43EA-93C5-3D37481503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13744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C3054-F838-4E6C-A918-8EF68719D4D9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19EED-20FB-43EA-93C5-3D37481503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91038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C3054-F838-4E6C-A918-8EF68719D4D9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19EED-20FB-43EA-93C5-3D37481503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835664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6C3054-F838-4E6C-A918-8EF68719D4D9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919EED-20FB-43EA-93C5-3D37481503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52499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3749156" y="6009103"/>
            <a:ext cx="54503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 Fig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no- and </a:t>
            </a:r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rboxy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erminal moieties of </a:t>
            </a: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PuL2 display signal activity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fr-F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Graphique 2"/>
          <p:cNvGraphicFramePr>
            <a:graphicFrameLocks/>
          </p:cNvGraphicFramePr>
          <p:nvPr>
            <p:extLst/>
          </p:nvPr>
        </p:nvGraphicFramePr>
        <p:xfrm>
          <a:off x="3662363" y="2057400"/>
          <a:ext cx="486727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ZoneTexte 3"/>
          <p:cNvSpPr txBox="1"/>
          <p:nvPr/>
        </p:nvSpPr>
        <p:spPr>
          <a:xfrm rot="16200000">
            <a:off x="1938408" y="3102524"/>
            <a:ext cx="31709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 sz="1200" b="0" i="0" u="none" strike="noStrike" kern="1200" baseline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r>
              <a:rPr lang="fr-FR" sz="1200" dirty="0">
                <a:latin typeface="Arial" pitchFamily="34" charset="0"/>
                <a:cs typeface="Arial" pitchFamily="34" charset="0"/>
              </a:rPr>
              <a:t>Miller </a:t>
            </a:r>
            <a:r>
              <a:rPr lang="fr-FR" sz="1200" dirty="0" err="1">
                <a:latin typeface="Arial" pitchFamily="34" charset="0"/>
                <a:cs typeface="Arial" pitchFamily="34" charset="0"/>
              </a:rPr>
              <a:t>units</a:t>
            </a:r>
            <a:r>
              <a:rPr lang="fr-FR" sz="1200" dirty="0">
                <a:latin typeface="Arial" pitchFamily="34" charset="0"/>
                <a:cs typeface="Arial" pitchFamily="34" charset="0"/>
              </a:rPr>
              <a:t>/µg of </a:t>
            </a:r>
            <a:r>
              <a:rPr lang="fr-FR" sz="1200" dirty="0" err="1">
                <a:latin typeface="Arial" pitchFamily="34" charset="0"/>
                <a:cs typeface="Arial" pitchFamily="34" charset="0"/>
              </a:rPr>
              <a:t>protein</a:t>
            </a:r>
            <a:r>
              <a:rPr lang="fr-FR" sz="1200" dirty="0">
                <a:latin typeface="Arial" pitchFamily="34" charset="0"/>
                <a:cs typeface="Arial" pitchFamily="34" charset="0"/>
              </a:rPr>
              <a:t> 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4936273" y="4641813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1-121</a:t>
            </a:r>
          </a:p>
        </p:txBody>
      </p:sp>
      <p:sp>
        <p:nvSpPr>
          <p:cNvPr id="7" name="ZoneTexte 6"/>
          <p:cNvSpPr txBox="1"/>
          <p:nvPr/>
        </p:nvSpPr>
        <p:spPr>
          <a:xfrm>
            <a:off x="6989212" y="4641813"/>
            <a:ext cx="7457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122-273</a:t>
            </a:r>
          </a:p>
        </p:txBody>
      </p:sp>
    </p:spTree>
    <p:extLst>
      <p:ext uri="{BB962C8B-B14F-4D97-AF65-F5344CB8AC3E}">
        <p14:creationId xmlns:p14="http://schemas.microsoft.com/office/powerpoint/2010/main" val="39264600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</Words>
  <Application>Microsoft Office PowerPoint</Application>
  <PresentationFormat>Grand écran</PresentationFormat>
  <Paragraphs>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batut</dc:creator>
  <cp:lastModifiedBy>jbatut</cp:lastModifiedBy>
  <cp:revision>1</cp:revision>
  <dcterms:created xsi:type="dcterms:W3CDTF">2020-02-27T11:34:35Z</dcterms:created>
  <dcterms:modified xsi:type="dcterms:W3CDTF">2020-02-27T11:35:09Z</dcterms:modified>
</cp:coreProperties>
</file>